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9" r:id="rId4"/>
  </p:sldIdLst>
  <p:sldSz cx="6858000" cy="9906000" type="A4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369" autoAdjust="0"/>
    <p:restoredTop sz="94660"/>
  </p:normalViewPr>
  <p:slideViewPr>
    <p:cSldViewPr snapToGrid="0">
      <p:cViewPr>
        <p:scale>
          <a:sx n="125" d="100"/>
          <a:sy n="125" d="100"/>
        </p:scale>
        <p:origin x="152" y="-3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28892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49964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98668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97207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90166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32259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851512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43493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35825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144643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US"/>
              <a:t>Click icon to add picture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95527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F713A-5EB9-4B7A-B87D-F2B7940161AF}" type="datetimeFigureOut">
              <a:rPr lang="en-NZ" smtClean="0"/>
              <a:t>6/01/20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23099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6811554"/>
              </p:ext>
            </p:extLst>
          </p:nvPr>
        </p:nvGraphicFramePr>
        <p:xfrm>
          <a:off x="401955" y="931795"/>
          <a:ext cx="5673090" cy="4527550"/>
        </p:xfrm>
        <a:graphic>
          <a:graphicData uri="http://schemas.openxmlformats.org/drawingml/2006/table">
            <a:tbl>
              <a:tblPr firstRow="1" firstCol="1" bandRow="1"/>
              <a:tblGrid>
                <a:gridCol w="2141220">
                  <a:extLst>
                    <a:ext uri="{9D8B030D-6E8A-4147-A177-3AD203B41FA5}">
                      <a16:colId xmlns:a16="http://schemas.microsoft.com/office/drawing/2014/main" val="4253403011"/>
                    </a:ext>
                  </a:extLst>
                </a:gridCol>
                <a:gridCol w="1753235">
                  <a:extLst>
                    <a:ext uri="{9D8B030D-6E8A-4147-A177-3AD203B41FA5}">
                      <a16:colId xmlns:a16="http://schemas.microsoft.com/office/drawing/2014/main" val="3623127399"/>
                    </a:ext>
                  </a:extLst>
                </a:gridCol>
                <a:gridCol w="1778635">
                  <a:extLst>
                    <a:ext uri="{9D8B030D-6E8A-4147-A177-3AD203B41FA5}">
                      <a16:colId xmlns:a16="http://schemas.microsoft.com/office/drawing/2014/main" val="1748736076"/>
                    </a:ext>
                  </a:extLst>
                </a:gridCol>
              </a:tblGrid>
              <a:tr h="2279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Non-diabetic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Type 2 diabetic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573912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Patient characteristics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985950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Age (years)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70 ± 2.3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72 ± 2.2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510208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Sex 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7M + 1F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4M + 3F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48328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BMI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30.2 ± 1.8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32.2 ± 1.4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95537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Beta blockers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5/8</a:t>
                      </a:r>
                      <a:endParaRPr lang="en-NZ" sz="1100" dirty="0">
                        <a:solidFill>
                          <a:schemeClr val="tx1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6/7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973983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ACE inhibitors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NZ" sz="11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en-NZ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Metformi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NZ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Insuli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NZ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Stati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3/8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0/8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NZ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0/8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NZ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4/8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4/7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6/7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5/7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7/7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98040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7981964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Cardiac dimensions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011385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IVSd (cm)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1.2 ± 0.1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1.3 ± 0.1 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438771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LVPWd (cm)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1.1 ± 0.1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1.1 ± 0.1 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426538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LVIDd (cm)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5.0 ± 0.4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4.8 ± 0.2 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736899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LVIDs (cm)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3.3 ± 0.4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3.3 ± 0.3 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918010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19955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Systolic function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21238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Fractional shortening (%)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33.9 ± 4.7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32.8 ± 4.8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352811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Ejection fraction (%)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57.4 ± 5.8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56.0 ± 4.6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99602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781914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Diastolic function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26891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E/A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ratio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1.1 ± 0.4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0.8 ± 0.1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49894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i="1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E/e’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ratio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9.3 ± 1.0</a:t>
                      </a:r>
                      <a:endParaRPr lang="en-NZ" sz="11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14.4 ± 1.8*</a:t>
                      </a:r>
                      <a:endParaRPr lang="en-NZ" sz="11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666839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    DCT (msec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251 ± 3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248 ± 2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657308"/>
                  </a:ext>
                </a:extLst>
              </a:tr>
            </a:tbl>
          </a:graphicData>
        </a:graphic>
      </p:graphicFrame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325438" y="5518038"/>
            <a:ext cx="5749607" cy="1600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Mean ± SEM. Full cohort of patients n=8 non-diabetic (ND) and n=7 type 2 diabetic (T2D). Echocardiography parameters were available from most but not all patients (as tabulated n=5-7/group). M, male; F, female; BMI, body mass index; ACE, angiotensin converting enzyme; </a:t>
            </a:r>
            <a:r>
              <a:rPr kumimoji="0" lang="en-US" altLang="en-US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IVSd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, interventricular septum thickness at end-diastole; </a:t>
            </a:r>
            <a:r>
              <a:rPr kumimoji="0" lang="en-US" altLang="en-US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LVPWd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, left ventricle posterior wall thickness at end-diastole; </a:t>
            </a:r>
            <a:r>
              <a:rPr kumimoji="0" lang="en-US" altLang="en-US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LVIDd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, left ventricle internal dimension at end-diastole; LVIDs, left ventricle internal dimension at end-systole; E/A, ratio of early (E) and atrial (A) mitral valve filling velocity;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E/e’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, ratio of early mitral filling velocity (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E)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to early diastolic mitral annular velocity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(e’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; DCT, deceleration time of early diastolic </a:t>
            </a:r>
            <a:r>
              <a:rPr kumimoji="0" lang="en-US" altLang="en-US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transmitral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 flow. Data were analyzed with an unpaired Student’s t-test, *p-value&lt;0.05. </a:t>
            </a:r>
            <a:endParaRPr kumimoji="0" lang="en-NZ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25438" y="546192"/>
            <a:ext cx="50901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Table S1. Patient characteristics and echocardiography data.</a:t>
            </a:r>
            <a:endParaRPr lang="en-NZ" altLang="en-US" sz="4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1074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414106" y="6630526"/>
            <a:ext cx="602978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Effect of fructose on cardiomyocyte metabolism </a:t>
            </a:r>
            <a:r>
              <a:rPr lang="en-NZ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onatal rat ventricular myocytes were cultured for 24 hours with 1mM fructose (</a:t>
            </a:r>
            <a:r>
              <a:rPr lang="en-NZ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u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s. control (Ctrl, 1mM mannitol). Cardiomyocyte mitochondrial function is unchanged with fructose (stress test: 1µM oligomycin &amp; 1µM FCCP; O</a:t>
            </a:r>
            <a:r>
              <a:rPr lang="en-NZ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umption rate normalized to protein (</a:t>
            </a:r>
            <a:r>
              <a:rPr lang="en-NZ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&amp; baseline). Oligo, oligomycin; FCCP, carbonyl cyanide-p-</a:t>
            </a:r>
            <a:r>
              <a:rPr lang="en-NZ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fluoromethoxyphenylhydrazone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=9 wells/group, 3 independent cultures. Repeated measures ANOVA. </a:t>
            </a:r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NZ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c2 </a:t>
            </a:r>
            <a:r>
              <a:rPr lang="en-NZ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diomyoblast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pid droplet Nile Red fluorescence normalized to DAPI nuclei stain fluorescence, is increased with fructose (n=14-16 wells/group, from 2 independent cultures). Mann Whitney U non-parametric test. *p-value&lt;0.05, mean ± SEM.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C84070A-4C92-6440-8530-BFCC3591052F}"/>
              </a:ext>
            </a:extLst>
          </p:cNvPr>
          <p:cNvSpPr txBox="1"/>
          <p:nvPr/>
        </p:nvSpPr>
        <p:spPr>
          <a:xfrm>
            <a:off x="955747" y="4163094"/>
            <a:ext cx="19960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In vitro NRVM cardiomyocyte </a:t>
            </a:r>
          </a:p>
          <a:p>
            <a:pPr algn="ctr"/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mitochondrial function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190" y="4617699"/>
            <a:ext cx="2416609" cy="18884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B33CFE-FBE3-4D49-8440-E1AEB6552049}"/>
              </a:ext>
            </a:extLst>
          </p:cNvPr>
          <p:cNvSpPr txBox="1"/>
          <p:nvPr/>
        </p:nvSpPr>
        <p:spPr>
          <a:xfrm>
            <a:off x="276320" y="2655001"/>
            <a:ext cx="60297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Cardiac fructose in type 2 diabetic rats. 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ac fructose levels are increased in type 2 diabetic Zucker Diabetic Fatty rats (ZDF) relative to controls (Ctrl), n=7/group. Students T-Test, *p-value&lt;0.05, mean ± SEM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4F4E0B-9E58-45F1-BA79-93F134C3CC6C}"/>
              </a:ext>
            </a:extLst>
          </p:cNvPr>
          <p:cNvSpPr txBox="1"/>
          <p:nvPr/>
        </p:nvSpPr>
        <p:spPr>
          <a:xfrm>
            <a:off x="1040165" y="529949"/>
            <a:ext cx="11705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T2D rodent </a:t>
            </a:r>
            <a:b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cardiac fructos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884248-568B-42A2-8604-80B7BD98E4E7}"/>
              </a:ext>
            </a:extLst>
          </p:cNvPr>
          <p:cNvSpPr txBox="1"/>
          <p:nvPr/>
        </p:nvSpPr>
        <p:spPr>
          <a:xfrm>
            <a:off x="3707439" y="4163094"/>
            <a:ext cx="14975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In vitro H9c2 </a:t>
            </a:r>
          </a:p>
          <a:p>
            <a:pPr algn="ctr"/>
            <a:r>
              <a:rPr lang="en-NZ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ardiomyoblast</a:t>
            </a:r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 lipid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8CA834E-0B4B-44CF-89AF-270C0C78C7BA}"/>
              </a:ext>
            </a:extLst>
          </p:cNvPr>
          <p:cNvSpPr txBox="1"/>
          <p:nvPr/>
        </p:nvSpPr>
        <p:spPr>
          <a:xfrm>
            <a:off x="468677" y="4004794"/>
            <a:ext cx="300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8B0FCB-966D-4739-A51A-656567779DC2}"/>
              </a:ext>
            </a:extLst>
          </p:cNvPr>
          <p:cNvSpPr txBox="1"/>
          <p:nvPr/>
        </p:nvSpPr>
        <p:spPr>
          <a:xfrm>
            <a:off x="3262376" y="4004794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18E56E1-E892-474A-B54E-4931AF17BB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0390" y="894627"/>
            <a:ext cx="1719567" cy="169948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B83ED8C-CA8D-4D7E-92E8-164A0555364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9497" y="4631080"/>
            <a:ext cx="1819542" cy="1699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34538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6896" y="9238850"/>
            <a:ext cx="60297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NZ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emplar immunoblots. A. 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ed </a:t>
            </a:r>
            <a:r>
              <a:rPr lang="en-NZ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NZ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ed AMPK. </a:t>
            </a:r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NZ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AMPK.</a:t>
            </a:r>
            <a:r>
              <a:rPr lang="en-NZ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NZ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200-000008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" t="4353" r="7115" b="-1"/>
          <a:stretch/>
        </p:blipFill>
        <p:spPr>
          <a:xfrm>
            <a:off x="1302157" y="2939483"/>
            <a:ext cx="2571428" cy="144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100-00000B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3" t="12289" r="1817" b="19405"/>
          <a:stretch/>
        </p:blipFill>
        <p:spPr>
          <a:xfrm>
            <a:off x="1302157" y="713866"/>
            <a:ext cx="2571428" cy="144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25618" y="516063"/>
            <a:ext cx="443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NZ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25618" y="2696984"/>
            <a:ext cx="443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NZ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5618" y="4785390"/>
            <a:ext cx="443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NZ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25618" y="6896380"/>
            <a:ext cx="443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en-NZ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98079" y="467645"/>
            <a:ext cx="17037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phosphorylated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NZ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1226856" y="2292365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66160" y="616748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093655" y="1197773"/>
            <a:ext cx="907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60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3912504" y="1305495"/>
            <a:ext cx="216000" cy="0"/>
          </a:xfrm>
          <a:prstGeom prst="line">
            <a:avLst/>
          </a:prstGeom>
          <a:ln w="127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736015" y="2708691"/>
            <a:ext cx="17037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total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NZ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1101872" y="360283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1101872" y="346694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684784" y="3371517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684784" y="3490990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1226856" y="4508995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766160" y="2876558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093655" y="3414403"/>
            <a:ext cx="907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60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912504" y="3522125"/>
            <a:ext cx="216000" cy="0"/>
          </a:xfrm>
          <a:prstGeom prst="line">
            <a:avLst/>
          </a:prstGeom>
          <a:ln w="127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Picture 49">
            <a:extLst>
              <a:ext uri="{FF2B5EF4-FFF2-40B4-BE49-F238E27FC236}">
                <a16:creationId xmlns:a16="http://schemas.microsoft.com/office/drawing/2014/main" id="{00000000-0008-0000-0100-000005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3" t="14985" r="728" b="13356"/>
          <a:stretch/>
        </p:blipFill>
        <p:spPr>
          <a:xfrm>
            <a:off x="1302156" y="5049479"/>
            <a:ext cx="2571429" cy="14400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00000000-0008-0000-0000-00000A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3" t="14473" r="2918" b="12909"/>
          <a:stretch/>
        </p:blipFill>
        <p:spPr>
          <a:xfrm>
            <a:off x="1302156" y="7253831"/>
            <a:ext cx="2571429" cy="1440000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1542047" y="4785108"/>
            <a:ext cx="2115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phosphorylated AMPK</a:t>
            </a:r>
            <a:endParaRPr lang="en-NZ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685904" y="7026154"/>
            <a:ext cx="17037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total AMPK</a:t>
            </a:r>
            <a:endParaRPr lang="en-NZ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1222304" y="6614080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761608" y="4906713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089103" y="5519488"/>
            <a:ext cx="907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MPK 62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/>
          <p:cNvCxnSpPr/>
          <p:nvPr/>
        </p:nvCxnSpPr>
        <p:spPr>
          <a:xfrm>
            <a:off x="3907952" y="5627210"/>
            <a:ext cx="216000" cy="0"/>
          </a:xfrm>
          <a:prstGeom prst="line">
            <a:avLst/>
          </a:prstGeom>
          <a:ln w="127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 rot="16200000">
            <a:off x="1214684" y="8815942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61608" y="7121275"/>
            <a:ext cx="574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089103" y="7793740"/>
            <a:ext cx="907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MPK 62kDa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68"/>
          <p:cNvCxnSpPr/>
          <p:nvPr/>
        </p:nvCxnSpPr>
        <p:spPr>
          <a:xfrm>
            <a:off x="3907952" y="7901462"/>
            <a:ext cx="216000" cy="0"/>
          </a:xfrm>
          <a:prstGeom prst="line">
            <a:avLst/>
          </a:prstGeom>
          <a:ln w="127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1101872" y="317484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1101872" y="330692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1101872" y="3404243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1101872" y="3697450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1101872" y="388731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1101872" y="3976850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684784" y="3070346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684784" y="3196028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684784" y="3288845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684784" y="3591221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684784" y="3780773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684784" y="3870671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1101872" y="4072614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684784" y="3966435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Connector 83"/>
          <p:cNvCxnSpPr/>
          <p:nvPr/>
        </p:nvCxnSpPr>
        <p:spPr>
          <a:xfrm>
            <a:off x="1115215" y="1428736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1115215" y="1250936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698126" y="1155508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98126" y="1316891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/>
          <p:cNvCxnSpPr/>
          <p:nvPr/>
        </p:nvCxnSpPr>
        <p:spPr>
          <a:xfrm>
            <a:off x="1115215" y="857871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1115215" y="999476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1115215" y="1157754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1115215" y="1523351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1115215" y="1776081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1115215" y="1865616"/>
            <a:ext cx="1376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698126" y="753372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698126" y="888579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698126" y="1048071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698126" y="1417122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698126" y="1669539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698126" y="1759437"/>
            <a:ext cx="50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Straight Connector 101"/>
          <p:cNvCxnSpPr/>
          <p:nvPr/>
        </p:nvCxnSpPr>
        <p:spPr>
          <a:xfrm>
            <a:off x="1119092" y="5710659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1119092" y="5532859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702004" y="5437431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02004" y="5598814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Straight Connector 105"/>
          <p:cNvCxnSpPr/>
          <p:nvPr/>
        </p:nvCxnSpPr>
        <p:spPr>
          <a:xfrm>
            <a:off x="1119092" y="5160749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>
            <a:off x="1119092" y="5309974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1119092" y="5453012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1119092" y="5847184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1119092" y="6115154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1119092" y="6246599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702004" y="5056250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702004" y="5199077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702004" y="5337614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702004" y="5740955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702004" y="6008612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702004" y="6140420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Straight Connector 117"/>
          <p:cNvCxnSpPr/>
          <p:nvPr/>
        </p:nvCxnSpPr>
        <p:spPr>
          <a:xfrm>
            <a:off x="1119092" y="6342363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702004" y="6236184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Straight Connector 119"/>
          <p:cNvCxnSpPr/>
          <p:nvPr/>
        </p:nvCxnSpPr>
        <p:spPr>
          <a:xfrm>
            <a:off x="1105949" y="7893490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1105949" y="772902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688861" y="7633597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688861" y="7781645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Straight Connector 123"/>
          <p:cNvCxnSpPr/>
          <p:nvPr/>
        </p:nvCxnSpPr>
        <p:spPr>
          <a:xfrm>
            <a:off x="1105949" y="737596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1105949" y="750804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1105949" y="7660608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1105949" y="8041445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1105949" y="8277030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>
          <a:xfrm>
            <a:off x="1105949" y="8383710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688861" y="7271466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688861" y="7397148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688861" y="7545210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688861" y="7935216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688861" y="8170488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688861" y="8277531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Straight Connector 135"/>
          <p:cNvCxnSpPr/>
          <p:nvPr/>
        </p:nvCxnSpPr>
        <p:spPr>
          <a:xfrm>
            <a:off x="1105949" y="8479474"/>
            <a:ext cx="1356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688861" y="8373295"/>
            <a:ext cx="495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NZ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8929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onsolas-Verdana">
      <a:majorFont>
        <a:latin typeface="Consolas" panose="020B0609020204030204"/>
        <a:ea typeface=""/>
        <a:cs typeface=""/>
        <a:font script="Jpan" typeface="HG丸ｺﾞｼｯｸM-PRO"/>
        <a:font script="Hang" typeface="HY중고딕"/>
        <a:font script="Hans" typeface="华文楷体"/>
        <a:font script="Hant" typeface="新細明體"/>
        <a:font script="Arab" typeface="Tahoma"/>
        <a:font script="Hebr" typeface="Levenim MT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Verdana" panose="020B060403050404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38E3E123-A269-4C2C-B83D-CCF8CE8D6D2D}" vid="{616D8776-4612-40CB-A629-823BC9E3883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8811</TotalTime>
  <Words>659</Words>
  <Application>Microsoft Office PowerPoint</Application>
  <PresentationFormat>A4 Paper (210x297 mm)</PresentationFormat>
  <Paragraphs>14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onsolas</vt:lpstr>
      <vt:lpstr>Times New Roman</vt:lpstr>
      <vt:lpstr>Verdana</vt:lpstr>
      <vt:lpstr>Office Theme</vt:lpstr>
      <vt:lpstr>PowerPoint Presentation</vt:lpstr>
      <vt:lpstr>PowerPoint Presentation</vt:lpstr>
      <vt:lpstr>PowerPoint Presentation</vt:lpstr>
    </vt:vector>
  </TitlesOfParts>
  <Company>The University of Auck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na Daniels</dc:creator>
  <cp:lastModifiedBy>Kim Mellor</cp:lastModifiedBy>
  <cp:revision>168</cp:revision>
  <cp:lastPrinted>2020-04-11T04:50:25Z</cp:lastPrinted>
  <dcterms:created xsi:type="dcterms:W3CDTF">2019-08-14T06:17:51Z</dcterms:created>
  <dcterms:modified xsi:type="dcterms:W3CDTF">2021-01-05T22:01:02Z</dcterms:modified>
</cp:coreProperties>
</file>